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8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71809-84EB-728D-6053-3FA42E4937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2E8F46-367E-25C2-9CD1-00B1554C42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1AD684-4078-EDDA-0F9B-6994637F7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C886FC-CD3C-41E8-D7BF-CF4142EB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4C5949-5EAD-0DB3-DD1E-5478E7D37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27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AABC1-CD5E-5EFF-89D4-D6A325D3F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F2041E-2EFA-6D80-3C3A-A4B7E97BB1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DDB4F4-0251-504B-844F-7CE3F692E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5FEC3-CB81-B83D-F168-BFAE006E7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68F54-080F-8B7E-772B-ED0052657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38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C94210-6013-D5CD-DAC2-5098BCD6A8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DD018F-40B1-F496-8F28-F9917E9B64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F4ECFF-4B4E-6B8D-6694-4C054DA2E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788D37-7CB7-7DF4-8302-6B344BE8F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12FAA-824C-BF39-6106-EF191B530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081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BA225-1AA9-4B2E-698A-07F98457B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560AC9-F28E-0B9B-ABE1-3DEF3BB7EC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9E263-F052-7FDA-CF76-08E3EBAE9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34D50-6756-5A7D-3BC7-284AD1800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11B3E6-64C5-021B-5971-3E3EABCFF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2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A577B-F353-3395-C642-23A37E58F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EA07F5-EAE2-C8D3-A971-43EF3E842D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22B12A-DC6D-1FD9-B2D2-862BD2EC5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D478E-AB42-5C55-06BC-6A3FCC22B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FB234F-EE17-E117-0660-AD3A98426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65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54979-A720-F51B-11A0-0956DEADE1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2E23F-4040-DE56-C8B2-406952840C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5F3886-A9C3-942A-F942-48F28ABE2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3AA20B-3582-F132-1682-EFCE77F95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3E350-F99D-3C60-ACB6-5A5D50DD1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2A48B3-E627-52AC-C493-E9C2465A2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240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88257-498A-A061-23D8-7AB7DEF93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8676AC-D607-CB84-1397-E2753F87C3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20CC96-059D-7937-0BDC-E10884A73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AB2BD1-941B-A974-C453-1A9B0A7A12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964FB9-7E82-166B-8E8F-92B34538A8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B5B1E9-25BC-A446-B195-3CF994440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D8308F-006C-5C1A-D2D7-B7B9545C5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9122EC-0F98-9842-AFCD-A1D61F598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575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EDE35-960C-5D70-0975-D838E76595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F01722-2857-98DF-8EC6-E1C6C171C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F152B0-298B-4628-75E0-BE0FFF419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C6B53F-37F1-50B0-41E9-4CE68CB9F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86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3A9F24-CD29-9F21-C118-2E9838586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B858D9-2463-D8BC-D20B-DBA0340D3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0FA327-EC93-C4AC-AD50-994B9E0A0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428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CB03F-9847-C305-79C1-1002A472E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B7C495-60EC-1D44-A86D-63F016809F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784E4C-DE5B-1E82-7EAC-B5A8BC1040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859101-E9AE-1526-144E-60EF9E7E8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12E089-DB36-5F97-9D05-91B1EBB22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68142-85B6-F708-E1F5-482AFDF2F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42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E85FD-0477-349D-C459-8C2B98435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F4FC84-ECF1-1506-AC52-FD47F2EA65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D58F79-D79B-205A-F000-98CCE3E98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BFFA4-0C26-DEB3-C56B-EEC956A19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61803-1EE9-B997-2AEA-9E814345E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9D3228-F668-D74B-4C5F-156CFDD55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6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6D8A09-E747-828F-A10B-F52707DC8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F18A04-B462-A53E-3640-3628B2E8ED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82162-C704-7497-9487-92C1681728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A7507C-0DBF-4112-92BE-B899CC8BA231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369F4-0CD6-C663-BBF0-7B94690E7D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7AA8E1-1188-7B45-C931-2918D0AF69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B442E2-722C-4288-942A-5BE5272DD7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35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BE7C5D9-54FF-208F-3CA8-DBF3F3A475F1}"/>
              </a:ext>
            </a:extLst>
          </p:cNvPr>
          <p:cNvGraphicFramePr>
            <a:graphicFrameLocks noGrp="1"/>
          </p:cNvGraphicFramePr>
          <p:nvPr/>
        </p:nvGraphicFramePr>
        <p:xfrm>
          <a:off x="2791609" y="1401639"/>
          <a:ext cx="4472316" cy="3115437"/>
        </p:xfrm>
        <a:graphic>
          <a:graphicData uri="http://schemas.openxmlformats.org/drawingml/2006/table">
            <a:tbl>
              <a:tblPr firstRow="1" firstCol="1" bandRow="1"/>
              <a:tblGrid>
                <a:gridCol w="2241864">
                  <a:extLst>
                    <a:ext uri="{9D8B030D-6E8A-4147-A177-3AD203B41FA5}">
                      <a16:colId xmlns:a16="http://schemas.microsoft.com/office/drawing/2014/main" val="2790009871"/>
                    </a:ext>
                  </a:extLst>
                </a:gridCol>
                <a:gridCol w="1051133">
                  <a:extLst>
                    <a:ext uri="{9D8B030D-6E8A-4147-A177-3AD203B41FA5}">
                      <a16:colId xmlns:a16="http://schemas.microsoft.com/office/drawing/2014/main" val="2630270326"/>
                    </a:ext>
                  </a:extLst>
                </a:gridCol>
                <a:gridCol w="1179319">
                  <a:extLst>
                    <a:ext uri="{9D8B030D-6E8A-4147-A177-3AD203B41FA5}">
                      <a16:colId xmlns:a16="http://schemas.microsoft.com/office/drawing/2014/main" val="588909254"/>
                    </a:ext>
                  </a:extLst>
                </a:gridCol>
              </a:tblGrid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 dirty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Vrinda" panose="020B0502040204020203" pitchFamily="34" charset="0"/>
                        </a:rPr>
                        <a:t>Antibody</a:t>
                      </a:r>
                      <a:endParaRPr lang="en-US" sz="1200" kern="100" dirty="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Vrinda" panose="020B0502040204020203" pitchFamily="34" charset="0"/>
                        </a:rPr>
                        <a:t>Source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>
                          <a:solidFill>
                            <a:srgbClr val="FFFFFF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Vrinda" panose="020B0502040204020203" pitchFamily="34" charset="0"/>
                        </a:rPr>
                        <a:t>Identifier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0369213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IL-1 alpha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bcam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b206410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502821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Lamin B1 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bcam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b16048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6821513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GAPDH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bcam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b9485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2467203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IL-1R1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nvitrogen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 dirty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 PA5-97866</a:t>
                      </a:r>
                      <a:endParaRPr lang="en-US" sz="1200" kern="100" dirty="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1372756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α-Tubulin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2144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4357607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E-Cadherin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 #3195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2055639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Claudin-1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13255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5346504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N-Cadherin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13116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2508792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Vimentin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5741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1592307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_EGFR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2232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7430576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p-EGFR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2220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7219860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GPX4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52455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7865009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4F2hc/SLC3A2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47213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2854544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xCT/SLC7A11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12691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2068853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FTH1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4393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687833"/>
                  </a:ext>
                </a:extLst>
              </a:tr>
              <a:tr h="18326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nti-Oct 4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ell Signaling</a:t>
                      </a:r>
                      <a:endParaRPr lang="en-US" sz="1200" kern="10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#2750</a:t>
                      </a:r>
                      <a:endParaRPr lang="en-US" sz="1200" kern="100" dirty="0">
                        <a:effectLst/>
                        <a:latin typeface="+mn-lt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605968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F23B576-799E-7580-FDE7-9A0D343B994D}"/>
              </a:ext>
            </a:extLst>
          </p:cNvPr>
          <p:cNvSpPr txBox="1"/>
          <p:nvPr/>
        </p:nvSpPr>
        <p:spPr>
          <a:xfrm>
            <a:off x="3234365" y="1124640"/>
            <a:ext cx="37669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Table 2: Antibodies for Western blot</a:t>
            </a:r>
          </a:p>
        </p:txBody>
      </p:sp>
    </p:spTree>
    <p:extLst>
      <p:ext uri="{BB962C8B-B14F-4D97-AF65-F5344CB8AC3E}">
        <p14:creationId xmlns:p14="http://schemas.microsoft.com/office/powerpoint/2010/main" val="2198200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rnett, Andrean L</dc:creator>
  <cp:lastModifiedBy>Burnett, Andrean L</cp:lastModifiedBy>
  <cp:revision>1</cp:revision>
  <dcterms:created xsi:type="dcterms:W3CDTF">2026-02-26T15:58:59Z</dcterms:created>
  <dcterms:modified xsi:type="dcterms:W3CDTF">2026-02-26T15:59:25Z</dcterms:modified>
</cp:coreProperties>
</file>